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52" r:id="rId1"/>
  </p:sldMasterIdLst>
  <p:sldIdLst>
    <p:sldId id="256" r:id="rId2"/>
  </p:sldIdLst>
  <p:sldSz cx="6300788" cy="52197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188" autoAdjust="0"/>
    <p:restoredTop sz="94601"/>
  </p:normalViewPr>
  <p:slideViewPr>
    <p:cSldViewPr snapToGrid="0">
      <p:cViewPr varScale="1">
        <p:scale>
          <a:sx n="162" d="100"/>
          <a:sy n="162" d="100"/>
        </p:scale>
        <p:origin x="2371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854243"/>
            <a:ext cx="5355670" cy="1817229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2741551"/>
            <a:ext cx="4725591" cy="1260219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687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84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277901"/>
            <a:ext cx="1358607" cy="442345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277901"/>
            <a:ext cx="3997062" cy="442345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101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227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1301302"/>
            <a:ext cx="5434430" cy="2171250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3493092"/>
            <a:ext cx="5434430" cy="1141809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1389503"/>
            <a:ext cx="2677835" cy="33118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1389503"/>
            <a:ext cx="2677835" cy="33118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953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277902"/>
            <a:ext cx="5434430" cy="100890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1279552"/>
            <a:ext cx="2665528" cy="627089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1906640"/>
            <a:ext cx="2665528" cy="280438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1279552"/>
            <a:ext cx="2678656" cy="627089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1906640"/>
            <a:ext cx="2678656" cy="280438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536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859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940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347980"/>
            <a:ext cx="2032168" cy="1217930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751541"/>
            <a:ext cx="3189774" cy="3709370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1565910"/>
            <a:ext cx="2032168" cy="2901042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980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347980"/>
            <a:ext cx="2032168" cy="1217930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751541"/>
            <a:ext cx="3189774" cy="3709370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1565910"/>
            <a:ext cx="2032168" cy="2901042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058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277902"/>
            <a:ext cx="5434430" cy="1008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1389503"/>
            <a:ext cx="5434430" cy="33118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4837890"/>
            <a:ext cx="1417677" cy="2779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BE92B5-CF5A-4EFF-B4E7-F16D0BB7B6F9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4837890"/>
            <a:ext cx="2126516" cy="2779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4837890"/>
            <a:ext cx="1417677" cy="2779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80E4E-F8AC-41D9-AE45-AA81A7C9A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391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53" r:id="rId1"/>
    <p:sldLayoutId id="2147483854" r:id="rId2"/>
    <p:sldLayoutId id="2147483855" r:id="rId3"/>
    <p:sldLayoutId id="2147483856" r:id="rId4"/>
    <p:sldLayoutId id="2147483857" r:id="rId5"/>
    <p:sldLayoutId id="2147483858" r:id="rId6"/>
    <p:sldLayoutId id="2147483859" r:id="rId7"/>
    <p:sldLayoutId id="2147483860" r:id="rId8"/>
    <p:sldLayoutId id="2147483861" r:id="rId9"/>
    <p:sldLayoutId id="2147483862" r:id="rId10"/>
    <p:sldLayoutId id="2147483863" r:id="rId11"/>
  </p:sldLayoutIdLst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4">
            <a:extLst>
              <a:ext uri="{FF2B5EF4-FFF2-40B4-BE49-F238E27FC236}">
                <a16:creationId xmlns:a16="http://schemas.microsoft.com/office/drawing/2014/main" id="{1013CBBD-3A07-4D97-A294-59585EFFBA4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30492" y="162128"/>
            <a:ext cx="1558708" cy="154230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C96362E-1CED-4CCF-943C-965929A1144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32092" y="162128"/>
            <a:ext cx="1558708" cy="1542301"/>
          </a:xfrm>
          <a:prstGeom prst="rect">
            <a:avLst/>
          </a:prstGeom>
        </p:spPr>
      </p:pic>
      <p:pic>
        <p:nvPicPr>
          <p:cNvPr id="9" name="图片 11">
            <a:extLst>
              <a:ext uri="{FF2B5EF4-FFF2-40B4-BE49-F238E27FC236}">
                <a16:creationId xmlns:a16="http://schemas.microsoft.com/office/drawing/2014/main" id="{9E0A0EBC-8CBC-45A9-B9AB-135D7BCEE93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30492" y="1746128"/>
            <a:ext cx="1558708" cy="1542301"/>
          </a:xfrm>
          <a:prstGeom prst="rect">
            <a:avLst/>
          </a:prstGeom>
        </p:spPr>
      </p:pic>
      <p:pic>
        <p:nvPicPr>
          <p:cNvPr id="10" name="图片 12">
            <a:extLst>
              <a:ext uri="{FF2B5EF4-FFF2-40B4-BE49-F238E27FC236}">
                <a16:creationId xmlns:a16="http://schemas.microsoft.com/office/drawing/2014/main" id="{62612B5B-6493-4002-9D83-9FDDD83F58D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32092" y="1746128"/>
            <a:ext cx="1558708" cy="1542301"/>
          </a:xfrm>
          <a:prstGeom prst="rect">
            <a:avLst/>
          </a:prstGeom>
        </p:spPr>
      </p:pic>
      <p:pic>
        <p:nvPicPr>
          <p:cNvPr id="12" name="图片 17">
            <a:extLst>
              <a:ext uri="{FF2B5EF4-FFF2-40B4-BE49-F238E27FC236}">
                <a16:creationId xmlns:a16="http://schemas.microsoft.com/office/drawing/2014/main" id="{CCFD8A86-2DCA-4CF6-A5F6-B0F71C6BA50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32092" y="3330128"/>
            <a:ext cx="1559273" cy="1542860"/>
          </a:xfrm>
          <a:prstGeom prst="rect">
            <a:avLst/>
          </a:prstGeom>
        </p:spPr>
      </p:pic>
      <p:pic>
        <p:nvPicPr>
          <p:cNvPr id="13" name="图片 18">
            <a:extLst>
              <a:ext uri="{FF2B5EF4-FFF2-40B4-BE49-F238E27FC236}">
                <a16:creationId xmlns:a16="http://schemas.microsoft.com/office/drawing/2014/main" id="{E05352D7-D6B1-4B19-93F6-8F66D4A8852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30492" y="3330128"/>
            <a:ext cx="1559273" cy="1542860"/>
          </a:xfrm>
          <a:prstGeom prst="rect">
            <a:avLst/>
          </a:prstGeom>
        </p:spPr>
      </p:pic>
      <p:grpSp>
        <p:nvGrpSpPr>
          <p:cNvPr id="14" name="组合 13">
            <a:extLst>
              <a:ext uri="{FF2B5EF4-FFF2-40B4-BE49-F238E27FC236}">
                <a16:creationId xmlns:a16="http://schemas.microsoft.com/office/drawing/2014/main" id="{4C7D9DDF-A283-E543-AA01-3E70C3BEE42B}"/>
              </a:ext>
            </a:extLst>
          </p:cNvPr>
          <p:cNvGrpSpPr/>
          <p:nvPr/>
        </p:nvGrpSpPr>
        <p:grpSpPr>
          <a:xfrm>
            <a:off x="5328892" y="162128"/>
            <a:ext cx="1049036" cy="667131"/>
            <a:chOff x="2776247" y="158099"/>
            <a:chExt cx="778778" cy="458359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3245B50C-AB07-CF4E-B1AF-C2DCEC2874F5}"/>
                </a:ext>
              </a:extLst>
            </p:cNvPr>
            <p:cNvSpPr/>
            <p:nvPr/>
          </p:nvSpPr>
          <p:spPr>
            <a:xfrm>
              <a:off x="2776247" y="207924"/>
              <a:ext cx="90000" cy="9066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345" tIns="45673" rIns="91345" bIns="4567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zh-CN" altLang="en-US" sz="1798"/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E2E658F-E70E-2A4A-B74E-D498E371469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76247" y="337318"/>
              <a:ext cx="90000" cy="90666"/>
            </a:xfrm>
            <a:prstGeom prst="rect">
              <a:avLst/>
            </a:prstGeom>
          </p:spPr>
        </p:pic>
        <p:pic>
          <p:nvPicPr>
            <p:cNvPr id="17" name="Picture 15">
              <a:extLst>
                <a:ext uri="{FF2B5EF4-FFF2-40B4-BE49-F238E27FC236}">
                  <a16:creationId xmlns:a16="http://schemas.microsoft.com/office/drawing/2014/main" id="{D9B67763-395C-284F-9907-262E7D02060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76375" y="474792"/>
              <a:ext cx="90000" cy="90000"/>
            </a:xfrm>
            <a:prstGeom prst="rect">
              <a:avLst/>
            </a:prstGeom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365AA836-0E71-CB4C-8877-0E947B041920}"/>
                </a:ext>
              </a:extLst>
            </p:cNvPr>
            <p:cNvSpPr txBox="1"/>
            <p:nvPr/>
          </p:nvSpPr>
          <p:spPr>
            <a:xfrm>
              <a:off x="2811018" y="158099"/>
              <a:ext cx="744007" cy="1903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Backgroun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3F8BD50A-425F-724B-9385-78563C37BBE2}"/>
                </a:ext>
              </a:extLst>
            </p:cNvPr>
            <p:cNvSpPr txBox="1"/>
            <p:nvPr/>
          </p:nvSpPr>
          <p:spPr>
            <a:xfrm>
              <a:off x="2811367" y="287493"/>
              <a:ext cx="667844" cy="1903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pitheliu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4088129-7E45-A744-80E2-D247FBF8B495}"/>
                </a:ext>
              </a:extLst>
            </p:cNvPr>
            <p:cNvSpPr txBox="1"/>
            <p:nvPr/>
          </p:nvSpPr>
          <p:spPr>
            <a:xfrm>
              <a:off x="2811018" y="426143"/>
              <a:ext cx="504810" cy="1903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trom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CD487BF6-CCDF-D44A-90CF-E83A60C67B1B}"/>
              </a:ext>
            </a:extLst>
          </p:cNvPr>
          <p:cNvSpPr txBox="1"/>
          <p:nvPr/>
        </p:nvSpPr>
        <p:spPr>
          <a:xfrm>
            <a:off x="258471" y="78501"/>
            <a:ext cx="319318" cy="3154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14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67ED36B-4D44-7E42-A83D-4374721C08FF}"/>
              </a:ext>
            </a:extLst>
          </p:cNvPr>
          <p:cNvSpPr txBox="1"/>
          <p:nvPr/>
        </p:nvSpPr>
        <p:spPr>
          <a:xfrm>
            <a:off x="257223" y="1672106"/>
            <a:ext cx="352396" cy="3154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14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8120B61-8358-784A-AC55-309D55B76498}"/>
              </a:ext>
            </a:extLst>
          </p:cNvPr>
          <p:cNvSpPr txBox="1"/>
          <p:nvPr/>
        </p:nvSpPr>
        <p:spPr>
          <a:xfrm>
            <a:off x="252533" y="3255668"/>
            <a:ext cx="361034" cy="3154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14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图片 35" descr="图片包含 山, 户外, 侧面, 覆盖&#10;&#10;描述已自动生成">
            <a:extLst>
              <a:ext uri="{FF2B5EF4-FFF2-40B4-BE49-F238E27FC236}">
                <a16:creationId xmlns:a16="http://schemas.microsoft.com/office/drawing/2014/main" id="{6E307527-8115-C541-8968-99CBB5A615EE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3692" y="3330128"/>
            <a:ext cx="1557192" cy="1540800"/>
          </a:xfrm>
          <a:prstGeom prst="rect">
            <a:avLst/>
          </a:prstGeom>
        </p:spPr>
      </p:pic>
      <p:pic>
        <p:nvPicPr>
          <p:cNvPr id="38" name="图片 37" descr="图片包含 山, 山谷, 自然, 覆盖&#10;&#10;描述已自动生成">
            <a:extLst>
              <a:ext uri="{FF2B5EF4-FFF2-40B4-BE49-F238E27FC236}">
                <a16:creationId xmlns:a16="http://schemas.microsoft.com/office/drawing/2014/main" id="{41FB08F7-3251-BB43-BAEF-21639A06419D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4766" y="162716"/>
            <a:ext cx="1557192" cy="1540800"/>
          </a:xfrm>
          <a:prstGeom prst="rect">
            <a:avLst/>
          </a:prstGeom>
        </p:spPr>
      </p:pic>
      <p:pic>
        <p:nvPicPr>
          <p:cNvPr id="40" name="图片 39" descr="图片包含 室内, 红色, 布, 躺&#10;&#10;描述已自动生成">
            <a:extLst>
              <a:ext uri="{FF2B5EF4-FFF2-40B4-BE49-F238E27FC236}">
                <a16:creationId xmlns:a16="http://schemas.microsoft.com/office/drawing/2014/main" id="{0B06A253-76B2-B342-830C-5146D55BCE89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4434" y="1746128"/>
            <a:ext cx="1557192" cy="154080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C1A49A31-02E4-4F8E-9518-167F8173FC59}"/>
              </a:ext>
            </a:extLst>
          </p:cNvPr>
          <p:cNvSpPr txBox="1"/>
          <p:nvPr/>
        </p:nvSpPr>
        <p:spPr>
          <a:xfrm rot="-5400000">
            <a:off x="-19719" y="890391"/>
            <a:ext cx="8515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xample 1</a:t>
            </a:r>
            <a:endParaRPr lang="zh-CN" altLang="en-US" sz="11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14B6DD6-63C3-4B17-893B-C9482F9D3D56}"/>
              </a:ext>
            </a:extLst>
          </p:cNvPr>
          <p:cNvSpPr txBox="1"/>
          <p:nvPr/>
        </p:nvSpPr>
        <p:spPr>
          <a:xfrm rot="-5400000">
            <a:off x="-10592" y="2338999"/>
            <a:ext cx="8515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xample 2</a:t>
            </a:r>
            <a:endParaRPr lang="zh-CN" altLang="en-US" sz="11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D8C2125-89F9-47F9-A4AE-79C087DD53BF}"/>
              </a:ext>
            </a:extLst>
          </p:cNvPr>
          <p:cNvSpPr txBox="1"/>
          <p:nvPr/>
        </p:nvSpPr>
        <p:spPr>
          <a:xfrm rot="-5400000">
            <a:off x="-43475" y="4003181"/>
            <a:ext cx="8515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xample 3</a:t>
            </a:r>
            <a:endParaRPr lang="zh-CN" altLang="en-US" sz="11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42D02C3-E739-D045-B692-E995CE90D2B6}"/>
              </a:ext>
            </a:extLst>
          </p:cNvPr>
          <p:cNvSpPr txBox="1"/>
          <p:nvPr/>
        </p:nvSpPr>
        <p:spPr>
          <a:xfrm>
            <a:off x="697250" y="4825706"/>
            <a:ext cx="12300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aw TCGA H&amp;E</a:t>
            </a:r>
            <a:r>
              <a:rPr kumimoji="1" lang="zh-CN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kumimoji="1"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atch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42D02C3-E739-D045-B692-E995CE90D2B6}"/>
              </a:ext>
            </a:extLst>
          </p:cNvPr>
          <p:cNvSpPr txBox="1"/>
          <p:nvPr/>
        </p:nvSpPr>
        <p:spPr>
          <a:xfrm>
            <a:off x="2092400" y="4870928"/>
            <a:ext cx="319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athologist annotation</a:t>
            </a:r>
            <a:r>
              <a:rPr kumimoji="1" lang="zh-CN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kumimoji="1" lang="en-US" altLang="zh-CN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caSeg</a:t>
            </a:r>
            <a:r>
              <a:rPr kumimoji="1" lang="zh-CN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3685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</TotalTime>
  <Words>21</Words>
  <Application>Microsoft Office PowerPoint</Application>
  <PresentationFormat>自定义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Theme</vt:lpstr>
      <vt:lpstr>PowerPoint 演示文稿</vt:lpstr>
    </vt:vector>
  </TitlesOfParts>
  <Company>IU Dept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, Zixiao</dc:creator>
  <cp:lastModifiedBy>焦玉霞</cp:lastModifiedBy>
  <cp:revision>12</cp:revision>
  <dcterms:created xsi:type="dcterms:W3CDTF">2019-12-24T03:29:33Z</dcterms:created>
  <dcterms:modified xsi:type="dcterms:W3CDTF">2021-07-08T09:03:39Z</dcterms:modified>
</cp:coreProperties>
</file>